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2" r:id="rId4"/>
    <p:sldId id="265" r:id="rId5"/>
    <p:sldId id="264" r:id="rId6"/>
    <p:sldId id="263" r:id="rId7"/>
    <p:sldId id="266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70394375944165"/>
          <c:y val="5.4801502753332315E-2"/>
          <c:w val="0.78457107839119333"/>
          <c:h val="0.76870905025760672"/>
        </c:manualLayout>
      </c:layout>
      <c:barChart>
        <c:barDir val="col"/>
        <c:grouping val="clustered"/>
        <c:varyColors val="0"/>
        <c:ser>
          <c:idx val="0"/>
          <c:order val="0"/>
          <c:tx>
            <c:v>22nt</c:v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Lit>
              <c:ptCount val="9"/>
              <c:pt idx="0">
                <c:v>Xch-1</c:v>
              </c:pt>
              <c:pt idx="1">
                <c:v>Xch-2</c:v>
              </c:pt>
              <c:pt idx="2">
                <c:v>Xch-Wh</c:v>
              </c:pt>
              <c:pt idx="3">
                <c:v>Dzh-Qyg</c:v>
              </c:pt>
              <c:pt idx="4">
                <c:v>Bzh-1</c:v>
              </c:pt>
              <c:pt idx="5">
                <c:v>Bzh-2</c:v>
              </c:pt>
              <c:pt idx="6">
                <c:v>Bzh-3</c:v>
              </c:pt>
              <c:pt idx="7">
                <c:v>Bzh-4</c:v>
              </c:pt>
              <c:pt idx="8">
                <c:v>Bzh-5</c:v>
              </c:pt>
            </c:strLit>
          </c:cat>
          <c:val>
            <c:numRef>
              <c:f>'[Chart in Microsoft Word]Sheet12'!$I$5:$Q$5</c:f>
              <c:numCache>
                <c:formatCode>General</c:formatCode>
                <c:ptCount val="9"/>
                <c:pt idx="0">
                  <c:v>1015235</c:v>
                </c:pt>
                <c:pt idx="1">
                  <c:v>1480690</c:v>
                </c:pt>
                <c:pt idx="2">
                  <c:v>967004</c:v>
                </c:pt>
                <c:pt idx="3">
                  <c:v>1050959</c:v>
                </c:pt>
                <c:pt idx="4">
                  <c:v>1025507</c:v>
                </c:pt>
                <c:pt idx="5">
                  <c:v>923437</c:v>
                </c:pt>
                <c:pt idx="6">
                  <c:v>1066282</c:v>
                </c:pt>
                <c:pt idx="7">
                  <c:v>1132875</c:v>
                </c:pt>
                <c:pt idx="8">
                  <c:v>753245</c:v>
                </c:pt>
              </c:numCache>
            </c:numRef>
          </c:val>
        </c:ser>
        <c:ser>
          <c:idx val="1"/>
          <c:order val="1"/>
          <c:tx>
            <c:v>24nt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Lit>
              <c:ptCount val="9"/>
              <c:pt idx="0">
                <c:v>Xch-1</c:v>
              </c:pt>
              <c:pt idx="1">
                <c:v>Xch-2</c:v>
              </c:pt>
              <c:pt idx="2">
                <c:v>Xch-Wh</c:v>
              </c:pt>
              <c:pt idx="3">
                <c:v>Dzh-Qyg</c:v>
              </c:pt>
              <c:pt idx="4">
                <c:v>Bzh-1</c:v>
              </c:pt>
              <c:pt idx="5">
                <c:v>Bzh-2</c:v>
              </c:pt>
              <c:pt idx="6">
                <c:v>Bzh-3</c:v>
              </c:pt>
              <c:pt idx="7">
                <c:v>Bzh-4</c:v>
              </c:pt>
              <c:pt idx="8">
                <c:v>Bzh-5</c:v>
              </c:pt>
            </c:strLit>
          </c:cat>
          <c:val>
            <c:numRef>
              <c:f>'[Chart in Microsoft Word]Sheet12'!$I$6:$Q$6</c:f>
              <c:numCache>
                <c:formatCode>General</c:formatCode>
                <c:ptCount val="9"/>
                <c:pt idx="0">
                  <c:v>2721799</c:v>
                </c:pt>
                <c:pt idx="1">
                  <c:v>1958673</c:v>
                </c:pt>
                <c:pt idx="2">
                  <c:v>2296923</c:v>
                </c:pt>
                <c:pt idx="3">
                  <c:v>2388357</c:v>
                </c:pt>
                <c:pt idx="4">
                  <c:v>3272562</c:v>
                </c:pt>
                <c:pt idx="5">
                  <c:v>3426178</c:v>
                </c:pt>
                <c:pt idx="6">
                  <c:v>2478147</c:v>
                </c:pt>
                <c:pt idx="7">
                  <c:v>2431046</c:v>
                </c:pt>
                <c:pt idx="8">
                  <c:v>2776752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3546976"/>
        <c:axId val="3550896"/>
      </c:barChart>
      <c:catAx>
        <c:axId val="3546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RNA Librar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50896"/>
        <c:crosses val="autoZero"/>
        <c:auto val="1"/>
        <c:lblAlgn val="ctr"/>
        <c:lblOffset val="100"/>
        <c:noMultiLvlLbl val="0"/>
      </c:catAx>
      <c:valAx>
        <c:axId val="35508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ads</a:t>
                </a:r>
              </a:p>
            </c:rich>
          </c:tx>
          <c:layout>
            <c:manualLayout>
              <c:xMode val="edge"/>
              <c:yMode val="edge"/>
              <c:x val="1.3647787595682373E-2"/>
              <c:y val="0.351158458133909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46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9654454768716607"/>
          <c:y val="1.7338068035613191E-2"/>
          <c:w val="8.5015739592036524E-2"/>
          <c:h val="0.151671452833101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Length Distribution of sRNA Xuancheng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825478539937963"/>
          <c:y val="0.15318547505836674"/>
          <c:w val="0.76165978877156948"/>
          <c:h val="0.6930865934770547"/>
        </c:manualLayout>
      </c:layout>
      <c:barChart>
        <c:barDir val="col"/>
        <c:grouping val="clustered"/>
        <c:varyColors val="0"/>
        <c:ser>
          <c:idx val="0"/>
          <c:order val="0"/>
          <c:tx>
            <c:v>Xch1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3"/>
              <c:pt idx="0">
                <c:v>18</c:v>
              </c:pt>
              <c:pt idx="1">
                <c:v>19</c:v>
              </c:pt>
              <c:pt idx="2">
                <c:v>20</c:v>
              </c:pt>
              <c:pt idx="3">
                <c:v>21</c:v>
              </c:pt>
              <c:pt idx="4">
                <c:v>22</c:v>
              </c:pt>
              <c:pt idx="5">
                <c:v>23</c:v>
              </c:pt>
              <c:pt idx="6">
                <c:v>24</c:v>
              </c:pt>
              <c:pt idx="7">
                <c:v>25</c:v>
              </c:pt>
              <c:pt idx="8">
                <c:v>26</c:v>
              </c:pt>
              <c:pt idx="9">
                <c:v>27</c:v>
              </c:pt>
              <c:pt idx="10">
                <c:v>28</c:v>
              </c:pt>
              <c:pt idx="11">
                <c:v>29</c:v>
              </c:pt>
              <c:pt idx="12">
                <c:v>30</c:v>
              </c:pt>
            </c:numLit>
          </c:cat>
          <c:val>
            <c:numRef>
              <c:f>Sheet2!$E$39:$E$51</c:f>
              <c:numCache>
                <c:formatCode>General</c:formatCode>
                <c:ptCount val="13"/>
                <c:pt idx="0">
                  <c:v>147171</c:v>
                </c:pt>
                <c:pt idx="1">
                  <c:v>200660</c:v>
                </c:pt>
                <c:pt idx="2">
                  <c:v>284625</c:v>
                </c:pt>
                <c:pt idx="3">
                  <c:v>728389</c:v>
                </c:pt>
                <c:pt idx="4">
                  <c:v>1025507</c:v>
                </c:pt>
                <c:pt idx="5">
                  <c:v>757244</c:v>
                </c:pt>
                <c:pt idx="6">
                  <c:v>3272562</c:v>
                </c:pt>
                <c:pt idx="7">
                  <c:v>311399</c:v>
                </c:pt>
                <c:pt idx="8">
                  <c:v>119874</c:v>
                </c:pt>
                <c:pt idx="9">
                  <c:v>97740</c:v>
                </c:pt>
                <c:pt idx="10">
                  <c:v>92032</c:v>
                </c:pt>
                <c:pt idx="11">
                  <c:v>84383</c:v>
                </c:pt>
                <c:pt idx="12">
                  <c:v>71515</c:v>
                </c:pt>
              </c:numCache>
            </c:numRef>
          </c:val>
        </c:ser>
        <c:ser>
          <c:idx val="1"/>
          <c:order val="1"/>
          <c:tx>
            <c:v>Xch2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3"/>
              <c:pt idx="0">
                <c:v>18</c:v>
              </c:pt>
              <c:pt idx="1">
                <c:v>19</c:v>
              </c:pt>
              <c:pt idx="2">
                <c:v>20</c:v>
              </c:pt>
              <c:pt idx="3">
                <c:v>21</c:v>
              </c:pt>
              <c:pt idx="4">
                <c:v>22</c:v>
              </c:pt>
              <c:pt idx="5">
                <c:v>23</c:v>
              </c:pt>
              <c:pt idx="6">
                <c:v>24</c:v>
              </c:pt>
              <c:pt idx="7">
                <c:v>25</c:v>
              </c:pt>
              <c:pt idx="8">
                <c:v>26</c:v>
              </c:pt>
              <c:pt idx="9">
                <c:v>27</c:v>
              </c:pt>
              <c:pt idx="10">
                <c:v>28</c:v>
              </c:pt>
              <c:pt idx="11">
                <c:v>29</c:v>
              </c:pt>
              <c:pt idx="12">
                <c:v>30</c:v>
              </c:pt>
            </c:numLit>
          </c:cat>
          <c:val>
            <c:numRef>
              <c:f>Sheet2!$F$39:$F$51</c:f>
              <c:numCache>
                <c:formatCode>General</c:formatCode>
                <c:ptCount val="13"/>
                <c:pt idx="0">
                  <c:v>231899</c:v>
                </c:pt>
                <c:pt idx="1">
                  <c:v>283975</c:v>
                </c:pt>
                <c:pt idx="2">
                  <c:v>383920</c:v>
                </c:pt>
                <c:pt idx="3">
                  <c:v>989143</c:v>
                </c:pt>
                <c:pt idx="4">
                  <c:v>1480690</c:v>
                </c:pt>
                <c:pt idx="5">
                  <c:v>630850</c:v>
                </c:pt>
                <c:pt idx="6">
                  <c:v>1958673</c:v>
                </c:pt>
                <c:pt idx="7">
                  <c:v>295767</c:v>
                </c:pt>
                <c:pt idx="8">
                  <c:v>153321</c:v>
                </c:pt>
                <c:pt idx="9">
                  <c:v>110981</c:v>
                </c:pt>
                <c:pt idx="10">
                  <c:v>87804</c:v>
                </c:pt>
                <c:pt idx="11">
                  <c:v>74309</c:v>
                </c:pt>
                <c:pt idx="12">
                  <c:v>645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7371248"/>
        <c:axId val="317371640"/>
      </c:barChart>
      <c:catAx>
        <c:axId val="3173712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Length (nt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371640"/>
        <c:crosses val="autoZero"/>
        <c:auto val="1"/>
        <c:lblAlgn val="ctr"/>
        <c:lblOffset val="100"/>
        <c:noMultiLvlLbl val="0"/>
      </c:catAx>
      <c:valAx>
        <c:axId val="317371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Reads</a:t>
                </a:r>
              </a:p>
            </c:rich>
          </c:tx>
          <c:layout>
            <c:manualLayout>
              <c:xMode val="edge"/>
              <c:yMode val="edge"/>
              <c:x val="2.3563261344051543E-2"/>
              <c:y val="0.431637065678539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3712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6126713327500717"/>
          <c:y val="0.187416746317115"/>
          <c:w val="0.13864282589676291"/>
          <c:h val="0.1870793318465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Length Distribution of sRNA </a:t>
            </a:r>
          </a:p>
        </c:rich>
      </c:tx>
      <c:layout>
        <c:manualLayout>
          <c:xMode val="edge"/>
          <c:yMode val="edge"/>
          <c:x val="0.31755049955772102"/>
          <c:y val="2.89855072463768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145041499324419"/>
          <c:y val="0.1465915000946256"/>
          <c:w val="0.74721525631923214"/>
          <c:h val="0.6875309857101195"/>
        </c:manualLayout>
      </c:layout>
      <c:barChart>
        <c:barDir val="col"/>
        <c:grouping val="clustered"/>
        <c:varyColors val="0"/>
        <c:ser>
          <c:idx val="0"/>
          <c:order val="0"/>
          <c:tx>
            <c:v>Xch-Wh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3"/>
              <c:pt idx="0">
                <c:v>18</c:v>
              </c:pt>
              <c:pt idx="1">
                <c:v>19</c:v>
              </c:pt>
              <c:pt idx="2">
                <c:v>20</c:v>
              </c:pt>
              <c:pt idx="3">
                <c:v>21</c:v>
              </c:pt>
              <c:pt idx="4">
                <c:v>22</c:v>
              </c:pt>
              <c:pt idx="5">
                <c:v>23</c:v>
              </c:pt>
              <c:pt idx="6">
                <c:v>24</c:v>
              </c:pt>
              <c:pt idx="7">
                <c:v>25</c:v>
              </c:pt>
              <c:pt idx="8">
                <c:v>26</c:v>
              </c:pt>
              <c:pt idx="9">
                <c:v>27</c:v>
              </c:pt>
              <c:pt idx="10">
                <c:v>28</c:v>
              </c:pt>
              <c:pt idx="11">
                <c:v>29</c:v>
              </c:pt>
              <c:pt idx="12">
                <c:v>30</c:v>
              </c:pt>
            </c:numLit>
          </c:cat>
          <c:val>
            <c:numRef>
              <c:f>Sheet2!$E$56:$E$68</c:f>
              <c:numCache>
                <c:formatCode>General</c:formatCode>
                <c:ptCount val="13"/>
                <c:pt idx="0">
                  <c:v>144419</c:v>
                </c:pt>
                <c:pt idx="1">
                  <c:v>194742</c:v>
                </c:pt>
                <c:pt idx="2">
                  <c:v>271815</c:v>
                </c:pt>
                <c:pt idx="3">
                  <c:v>656980</c:v>
                </c:pt>
                <c:pt idx="4">
                  <c:v>967004</c:v>
                </c:pt>
                <c:pt idx="5">
                  <c:v>550662</c:v>
                </c:pt>
                <c:pt idx="6">
                  <c:v>2296923</c:v>
                </c:pt>
                <c:pt idx="7">
                  <c:v>235990</c:v>
                </c:pt>
                <c:pt idx="8">
                  <c:v>100968</c:v>
                </c:pt>
                <c:pt idx="9">
                  <c:v>80955</c:v>
                </c:pt>
                <c:pt idx="10">
                  <c:v>70397</c:v>
                </c:pt>
                <c:pt idx="11">
                  <c:v>62708</c:v>
                </c:pt>
                <c:pt idx="12">
                  <c:v>55306</c:v>
                </c:pt>
              </c:numCache>
            </c:numRef>
          </c:val>
        </c:ser>
        <c:ser>
          <c:idx val="1"/>
          <c:order val="1"/>
          <c:tx>
            <c:v>Dzh-Qyg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3"/>
              <c:pt idx="0">
                <c:v>18</c:v>
              </c:pt>
              <c:pt idx="1">
                <c:v>19</c:v>
              </c:pt>
              <c:pt idx="2">
                <c:v>20</c:v>
              </c:pt>
              <c:pt idx="3">
                <c:v>21</c:v>
              </c:pt>
              <c:pt idx="4">
                <c:v>22</c:v>
              </c:pt>
              <c:pt idx="5">
                <c:v>23</c:v>
              </c:pt>
              <c:pt idx="6">
                <c:v>24</c:v>
              </c:pt>
              <c:pt idx="7">
                <c:v>25</c:v>
              </c:pt>
              <c:pt idx="8">
                <c:v>26</c:v>
              </c:pt>
              <c:pt idx="9">
                <c:v>27</c:v>
              </c:pt>
              <c:pt idx="10">
                <c:v>28</c:v>
              </c:pt>
              <c:pt idx="11">
                <c:v>29</c:v>
              </c:pt>
              <c:pt idx="12">
                <c:v>30</c:v>
              </c:pt>
            </c:numLit>
          </c:cat>
          <c:val>
            <c:numRef>
              <c:f>Sheet2!$F$56:$F$68</c:f>
              <c:numCache>
                <c:formatCode>General</c:formatCode>
                <c:ptCount val="13"/>
                <c:pt idx="0">
                  <c:v>158289</c:v>
                </c:pt>
                <c:pt idx="1">
                  <c:v>198945</c:v>
                </c:pt>
                <c:pt idx="2">
                  <c:v>275816</c:v>
                </c:pt>
                <c:pt idx="3">
                  <c:v>736010</c:v>
                </c:pt>
                <c:pt idx="4">
                  <c:v>1050959</c:v>
                </c:pt>
                <c:pt idx="5">
                  <c:v>604813</c:v>
                </c:pt>
                <c:pt idx="6">
                  <c:v>2388357</c:v>
                </c:pt>
                <c:pt idx="7">
                  <c:v>297239</c:v>
                </c:pt>
                <c:pt idx="8">
                  <c:v>138109</c:v>
                </c:pt>
                <c:pt idx="9">
                  <c:v>100883</c:v>
                </c:pt>
                <c:pt idx="10">
                  <c:v>82105</c:v>
                </c:pt>
                <c:pt idx="11">
                  <c:v>71874</c:v>
                </c:pt>
                <c:pt idx="12">
                  <c:v>638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7372424"/>
        <c:axId val="317372816"/>
      </c:barChart>
      <c:catAx>
        <c:axId val="3173724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Length (</a:t>
                </a:r>
                <a:r>
                  <a:rPr lang="en-US" b="1" dirty="0" err="1"/>
                  <a:t>nt</a:t>
                </a:r>
                <a:r>
                  <a:rPr lang="en-US" b="1" dirty="0"/>
                  <a:t>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372816"/>
        <c:crosses val="autoZero"/>
        <c:auto val="1"/>
        <c:lblAlgn val="ctr"/>
        <c:lblOffset val="100"/>
        <c:noMultiLvlLbl val="0"/>
      </c:catAx>
      <c:valAx>
        <c:axId val="3173728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Read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372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4899499365498756"/>
          <c:y val="0.13247875103694939"/>
          <c:w val="0.16636086805444533"/>
          <c:h val="0.211281484551273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Length Distribution of sRNA Bozhou </a:t>
            </a:r>
          </a:p>
        </c:rich>
      </c:tx>
      <c:layout>
        <c:manualLayout>
          <c:xMode val="edge"/>
          <c:yMode val="edge"/>
          <c:x val="0.24282633420822403"/>
          <c:y val="3.24074074074074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2363954505686789"/>
          <c:y val="0.14260106133021583"/>
          <c:w val="0.73999781277340337"/>
          <c:h val="0.65512357830271217"/>
        </c:manualLayout>
      </c:layout>
      <c:barChart>
        <c:barDir val="col"/>
        <c:grouping val="clustered"/>
        <c:varyColors val="0"/>
        <c:ser>
          <c:idx val="0"/>
          <c:order val="0"/>
          <c:tx>
            <c:v>Bzh1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3"/>
              <c:pt idx="0">
                <c:v>18</c:v>
              </c:pt>
              <c:pt idx="1">
                <c:v>19</c:v>
              </c:pt>
              <c:pt idx="2">
                <c:v>20</c:v>
              </c:pt>
              <c:pt idx="3">
                <c:v>21</c:v>
              </c:pt>
              <c:pt idx="4">
                <c:v>22</c:v>
              </c:pt>
              <c:pt idx="5">
                <c:v>23</c:v>
              </c:pt>
              <c:pt idx="6">
                <c:v>24</c:v>
              </c:pt>
              <c:pt idx="7">
                <c:v>25</c:v>
              </c:pt>
              <c:pt idx="8">
                <c:v>26</c:v>
              </c:pt>
              <c:pt idx="9">
                <c:v>27</c:v>
              </c:pt>
              <c:pt idx="10">
                <c:v>28</c:v>
              </c:pt>
              <c:pt idx="11">
                <c:v>29</c:v>
              </c:pt>
              <c:pt idx="12">
                <c:v>30</c:v>
              </c:pt>
            </c:numLit>
          </c:cat>
          <c:val>
            <c:numRef>
              <c:f>Sheet2!$E$5:$E$17</c:f>
              <c:numCache>
                <c:formatCode>General</c:formatCode>
                <c:ptCount val="13"/>
                <c:pt idx="0">
                  <c:v>147171</c:v>
                </c:pt>
                <c:pt idx="1">
                  <c:v>200660</c:v>
                </c:pt>
                <c:pt idx="2">
                  <c:v>284625</c:v>
                </c:pt>
                <c:pt idx="3">
                  <c:v>728389</c:v>
                </c:pt>
                <c:pt idx="4">
                  <c:v>1025507</c:v>
                </c:pt>
                <c:pt idx="5">
                  <c:v>757244</c:v>
                </c:pt>
                <c:pt idx="6">
                  <c:v>3272562</c:v>
                </c:pt>
                <c:pt idx="7">
                  <c:v>311399</c:v>
                </c:pt>
                <c:pt idx="8">
                  <c:v>119874</c:v>
                </c:pt>
                <c:pt idx="9">
                  <c:v>97740</c:v>
                </c:pt>
                <c:pt idx="10">
                  <c:v>92032</c:v>
                </c:pt>
                <c:pt idx="11">
                  <c:v>84383</c:v>
                </c:pt>
                <c:pt idx="12">
                  <c:v>71515</c:v>
                </c:pt>
              </c:numCache>
            </c:numRef>
          </c:val>
        </c:ser>
        <c:ser>
          <c:idx val="1"/>
          <c:order val="1"/>
          <c:tx>
            <c:v>Bzh2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3"/>
              <c:pt idx="0">
                <c:v>18</c:v>
              </c:pt>
              <c:pt idx="1">
                <c:v>19</c:v>
              </c:pt>
              <c:pt idx="2">
                <c:v>20</c:v>
              </c:pt>
              <c:pt idx="3">
                <c:v>21</c:v>
              </c:pt>
              <c:pt idx="4">
                <c:v>22</c:v>
              </c:pt>
              <c:pt idx="5">
                <c:v>23</c:v>
              </c:pt>
              <c:pt idx="6">
                <c:v>24</c:v>
              </c:pt>
              <c:pt idx="7">
                <c:v>25</c:v>
              </c:pt>
              <c:pt idx="8">
                <c:v>26</c:v>
              </c:pt>
              <c:pt idx="9">
                <c:v>27</c:v>
              </c:pt>
              <c:pt idx="10">
                <c:v>28</c:v>
              </c:pt>
              <c:pt idx="11">
                <c:v>29</c:v>
              </c:pt>
              <c:pt idx="12">
                <c:v>30</c:v>
              </c:pt>
            </c:numLit>
          </c:cat>
          <c:val>
            <c:numRef>
              <c:f>Sheet2!$F$5:$F$17</c:f>
              <c:numCache>
                <c:formatCode>General</c:formatCode>
                <c:ptCount val="13"/>
                <c:pt idx="0">
                  <c:v>150005</c:v>
                </c:pt>
                <c:pt idx="1">
                  <c:v>212846</c:v>
                </c:pt>
                <c:pt idx="2">
                  <c:v>285197</c:v>
                </c:pt>
                <c:pt idx="3">
                  <c:v>621358</c:v>
                </c:pt>
                <c:pt idx="4">
                  <c:v>923437</c:v>
                </c:pt>
                <c:pt idx="5">
                  <c:v>897174</c:v>
                </c:pt>
                <c:pt idx="6">
                  <c:v>3426178</c:v>
                </c:pt>
                <c:pt idx="7">
                  <c:v>387735</c:v>
                </c:pt>
                <c:pt idx="8">
                  <c:v>128914</c:v>
                </c:pt>
                <c:pt idx="9">
                  <c:v>86814</c:v>
                </c:pt>
                <c:pt idx="10">
                  <c:v>71869</c:v>
                </c:pt>
                <c:pt idx="11">
                  <c:v>64230</c:v>
                </c:pt>
                <c:pt idx="12">
                  <c:v>57940</c:v>
                </c:pt>
              </c:numCache>
            </c:numRef>
          </c:val>
        </c:ser>
        <c:ser>
          <c:idx val="2"/>
          <c:order val="2"/>
          <c:tx>
            <c:v>Bzh3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3"/>
              <c:pt idx="0">
                <c:v>18</c:v>
              </c:pt>
              <c:pt idx="1">
                <c:v>19</c:v>
              </c:pt>
              <c:pt idx="2">
                <c:v>20</c:v>
              </c:pt>
              <c:pt idx="3">
                <c:v>21</c:v>
              </c:pt>
              <c:pt idx="4">
                <c:v>22</c:v>
              </c:pt>
              <c:pt idx="5">
                <c:v>23</c:v>
              </c:pt>
              <c:pt idx="6">
                <c:v>24</c:v>
              </c:pt>
              <c:pt idx="7">
                <c:v>25</c:v>
              </c:pt>
              <c:pt idx="8">
                <c:v>26</c:v>
              </c:pt>
              <c:pt idx="9">
                <c:v>27</c:v>
              </c:pt>
              <c:pt idx="10">
                <c:v>28</c:v>
              </c:pt>
              <c:pt idx="11">
                <c:v>29</c:v>
              </c:pt>
              <c:pt idx="12">
                <c:v>30</c:v>
              </c:pt>
            </c:numLit>
          </c:cat>
          <c:val>
            <c:numRef>
              <c:f>Sheet2!$G$5:$G$17</c:f>
              <c:numCache>
                <c:formatCode>General</c:formatCode>
                <c:ptCount val="13"/>
                <c:pt idx="0">
                  <c:v>173836</c:v>
                </c:pt>
                <c:pt idx="1">
                  <c:v>221638</c:v>
                </c:pt>
                <c:pt idx="2">
                  <c:v>300881</c:v>
                </c:pt>
                <c:pt idx="3">
                  <c:v>648189</c:v>
                </c:pt>
                <c:pt idx="4">
                  <c:v>1066282</c:v>
                </c:pt>
                <c:pt idx="5">
                  <c:v>833553</c:v>
                </c:pt>
                <c:pt idx="6">
                  <c:v>2478147</c:v>
                </c:pt>
                <c:pt idx="7">
                  <c:v>257793</c:v>
                </c:pt>
                <c:pt idx="8">
                  <c:v>81614</c:v>
                </c:pt>
                <c:pt idx="9">
                  <c:v>62081</c:v>
                </c:pt>
                <c:pt idx="10">
                  <c:v>54520</c:v>
                </c:pt>
                <c:pt idx="11">
                  <c:v>49796</c:v>
                </c:pt>
                <c:pt idx="12">
                  <c:v>44536</c:v>
                </c:pt>
              </c:numCache>
            </c:numRef>
          </c:val>
        </c:ser>
        <c:ser>
          <c:idx val="3"/>
          <c:order val="3"/>
          <c:tx>
            <c:v>Bzh4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3"/>
              <c:pt idx="0">
                <c:v>18</c:v>
              </c:pt>
              <c:pt idx="1">
                <c:v>19</c:v>
              </c:pt>
              <c:pt idx="2">
                <c:v>20</c:v>
              </c:pt>
              <c:pt idx="3">
                <c:v>21</c:v>
              </c:pt>
              <c:pt idx="4">
                <c:v>22</c:v>
              </c:pt>
              <c:pt idx="5">
                <c:v>23</c:v>
              </c:pt>
              <c:pt idx="6">
                <c:v>24</c:v>
              </c:pt>
              <c:pt idx="7">
                <c:v>25</c:v>
              </c:pt>
              <c:pt idx="8">
                <c:v>26</c:v>
              </c:pt>
              <c:pt idx="9">
                <c:v>27</c:v>
              </c:pt>
              <c:pt idx="10">
                <c:v>28</c:v>
              </c:pt>
              <c:pt idx="11">
                <c:v>29</c:v>
              </c:pt>
              <c:pt idx="12">
                <c:v>30</c:v>
              </c:pt>
            </c:numLit>
          </c:cat>
          <c:val>
            <c:numRef>
              <c:f>Sheet2!$H$5:$H$17</c:f>
              <c:numCache>
                <c:formatCode>General</c:formatCode>
                <c:ptCount val="13"/>
                <c:pt idx="0">
                  <c:v>180652</c:v>
                </c:pt>
                <c:pt idx="1">
                  <c:v>235873</c:v>
                </c:pt>
                <c:pt idx="2">
                  <c:v>302303</c:v>
                </c:pt>
                <c:pt idx="3">
                  <c:v>629838</c:v>
                </c:pt>
                <c:pt idx="4">
                  <c:v>1132875</c:v>
                </c:pt>
                <c:pt idx="5">
                  <c:v>952235</c:v>
                </c:pt>
                <c:pt idx="6">
                  <c:v>2431046</c:v>
                </c:pt>
                <c:pt idx="7">
                  <c:v>284669</c:v>
                </c:pt>
                <c:pt idx="8">
                  <c:v>93659</c:v>
                </c:pt>
                <c:pt idx="9">
                  <c:v>66324</c:v>
                </c:pt>
                <c:pt idx="10">
                  <c:v>56365</c:v>
                </c:pt>
                <c:pt idx="11">
                  <c:v>50907</c:v>
                </c:pt>
                <c:pt idx="12">
                  <c:v>45246</c:v>
                </c:pt>
              </c:numCache>
            </c:numRef>
          </c:val>
        </c:ser>
        <c:ser>
          <c:idx val="4"/>
          <c:order val="4"/>
          <c:tx>
            <c:v>Bzh5</c:v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3"/>
              <c:pt idx="0">
                <c:v>18</c:v>
              </c:pt>
              <c:pt idx="1">
                <c:v>19</c:v>
              </c:pt>
              <c:pt idx="2">
                <c:v>20</c:v>
              </c:pt>
              <c:pt idx="3">
                <c:v>21</c:v>
              </c:pt>
              <c:pt idx="4">
                <c:v>22</c:v>
              </c:pt>
              <c:pt idx="5">
                <c:v>23</c:v>
              </c:pt>
              <c:pt idx="6">
                <c:v>24</c:v>
              </c:pt>
              <c:pt idx="7">
                <c:v>25</c:v>
              </c:pt>
              <c:pt idx="8">
                <c:v>26</c:v>
              </c:pt>
              <c:pt idx="9">
                <c:v>27</c:v>
              </c:pt>
              <c:pt idx="10">
                <c:v>28</c:v>
              </c:pt>
              <c:pt idx="11">
                <c:v>29</c:v>
              </c:pt>
              <c:pt idx="12">
                <c:v>30</c:v>
              </c:pt>
            </c:numLit>
          </c:cat>
          <c:val>
            <c:numRef>
              <c:f>Sheet2!$I$5:$I$17</c:f>
              <c:numCache>
                <c:formatCode>General</c:formatCode>
                <c:ptCount val="13"/>
                <c:pt idx="0">
                  <c:v>87529</c:v>
                </c:pt>
                <c:pt idx="1">
                  <c:v>126426</c:v>
                </c:pt>
                <c:pt idx="2">
                  <c:v>191469</c:v>
                </c:pt>
                <c:pt idx="3">
                  <c:v>510750</c:v>
                </c:pt>
                <c:pt idx="4">
                  <c:v>753245</c:v>
                </c:pt>
                <c:pt idx="5">
                  <c:v>587917</c:v>
                </c:pt>
                <c:pt idx="6">
                  <c:v>2776752</c:v>
                </c:pt>
                <c:pt idx="7">
                  <c:v>270627</c:v>
                </c:pt>
                <c:pt idx="8">
                  <c:v>98652</c:v>
                </c:pt>
                <c:pt idx="9">
                  <c:v>84129</c:v>
                </c:pt>
                <c:pt idx="10">
                  <c:v>78517</c:v>
                </c:pt>
                <c:pt idx="11">
                  <c:v>75964</c:v>
                </c:pt>
                <c:pt idx="12">
                  <c:v>710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3846984"/>
        <c:axId val="293847376"/>
      </c:barChart>
      <c:catAx>
        <c:axId val="2938469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Length (nt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3847376"/>
        <c:crosses val="autoZero"/>
        <c:auto val="1"/>
        <c:lblAlgn val="ctr"/>
        <c:lblOffset val="100"/>
        <c:noMultiLvlLbl val="0"/>
      </c:catAx>
      <c:valAx>
        <c:axId val="2938473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Read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38469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8526578517307977"/>
          <c:y val="0.15674629654344058"/>
          <c:w val="0.1336589907393651"/>
          <c:h val="0.390627734033245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574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233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367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493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395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186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8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826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023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594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670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1473E-993B-447F-BFC4-D7F3F229C87A}" type="datetimeFigureOut">
              <a:rPr lang="en-US" smtClean="0"/>
              <a:t>2016-09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FFDE88-1582-4E32-94F5-2D0E8884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419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3600" smtClean="0"/>
              <a:t>Supplementary Figures</a:t>
            </a:r>
            <a:endParaRPr lang="en-US" sz="36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7142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97280" y="5895840"/>
            <a:ext cx="6671535" cy="386625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/>
              <a:t>Fig S2(</a:t>
            </a:r>
            <a:r>
              <a:rPr lang="en-US" sz="1200" b="1" dirty="0" err="1" smtClean="0"/>
              <a:t>a,b,c</a:t>
            </a:r>
            <a:r>
              <a:rPr lang="en-US" sz="1200" b="1" dirty="0" smtClean="0"/>
              <a:t>): </a:t>
            </a:r>
            <a:r>
              <a:rPr lang="en-US" sz="1200" dirty="0"/>
              <a:t>Length  distribution of total </a:t>
            </a:r>
            <a:r>
              <a:rPr lang="en-US" sz="1200" dirty="0" err="1"/>
              <a:t>sRNAs</a:t>
            </a:r>
            <a:r>
              <a:rPr lang="en-US" sz="1200" dirty="0"/>
              <a:t> (18 to 30 </a:t>
            </a:r>
            <a:r>
              <a:rPr lang="en-US" sz="1200" dirty="0" err="1"/>
              <a:t>nt</a:t>
            </a:r>
            <a:r>
              <a:rPr lang="en-US" sz="1200" dirty="0"/>
              <a:t>) in the nine libraries</a:t>
            </a:r>
          </a:p>
        </p:txBody>
      </p:sp>
      <p:graphicFrame>
        <p:nvGraphicFramePr>
          <p:cNvPr id="4" name="Chart 3"/>
          <p:cNvGraphicFramePr/>
          <p:nvPr>
            <p:extLst/>
          </p:nvPr>
        </p:nvGraphicFramePr>
        <p:xfrm>
          <a:off x="932329" y="391123"/>
          <a:ext cx="5486400" cy="22491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1599834" y="2629535"/>
            <a:ext cx="4427366" cy="28995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200" b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S1: 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2 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24 </a:t>
            </a:r>
            <a:r>
              <a:rPr lang="en-US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t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eak distribution of the libraries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Chart 12"/>
          <p:cNvGraphicFramePr/>
          <p:nvPr>
            <p:extLst/>
          </p:nvPr>
        </p:nvGraphicFramePr>
        <p:xfrm>
          <a:off x="6884894" y="537882"/>
          <a:ext cx="4468906" cy="24204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/>
          <p:cNvGraphicFramePr/>
          <p:nvPr>
            <p:extLst/>
          </p:nvPr>
        </p:nvGraphicFramePr>
        <p:xfrm>
          <a:off x="1269402" y="3689873"/>
          <a:ext cx="4722607" cy="2097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/>
          <p:nvPr>
            <p:extLst/>
          </p:nvPr>
        </p:nvGraphicFramePr>
        <p:xfrm>
          <a:off x="6970955" y="3555645"/>
          <a:ext cx="4281544" cy="22534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" name="Rectangle 15"/>
          <p:cNvSpPr/>
          <p:nvPr/>
        </p:nvSpPr>
        <p:spPr>
          <a:xfrm>
            <a:off x="7135036" y="210677"/>
            <a:ext cx="7395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b</a:t>
            </a:r>
            <a:endParaRPr lang="en-US" sz="1200" dirty="0"/>
          </a:p>
        </p:txBody>
      </p:sp>
      <p:sp>
        <p:nvSpPr>
          <p:cNvPr id="17" name="Rectangle 16"/>
          <p:cNvSpPr/>
          <p:nvPr/>
        </p:nvSpPr>
        <p:spPr>
          <a:xfrm>
            <a:off x="628453" y="3568856"/>
            <a:ext cx="28594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a</a:t>
            </a:r>
            <a:endParaRPr lang="en-US" sz="1200" dirty="0"/>
          </a:p>
        </p:txBody>
      </p:sp>
      <p:sp>
        <p:nvSpPr>
          <p:cNvPr id="18" name="Rectangle 17"/>
          <p:cNvSpPr/>
          <p:nvPr/>
        </p:nvSpPr>
        <p:spPr>
          <a:xfrm>
            <a:off x="7029253" y="3199524"/>
            <a:ext cx="7395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c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681981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4233" y="6225727"/>
            <a:ext cx="8252010" cy="339519"/>
          </a:xfrm>
        </p:spPr>
        <p:txBody>
          <a:bodyPr>
            <a:no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/>
              <a:t>Fig S3: </a:t>
            </a:r>
            <a:r>
              <a:rPr lang="en-US" sz="1200" dirty="0" smtClean="0"/>
              <a:t>Distribution of </a:t>
            </a:r>
            <a:r>
              <a:rPr lang="en-US" sz="1200" dirty="0" err="1" smtClean="0"/>
              <a:t>siRNA</a:t>
            </a:r>
            <a:r>
              <a:rPr lang="en-US" sz="1200" dirty="0" smtClean="0"/>
              <a:t> Reads on Reference Genome shows coverage across the reference</a:t>
            </a:r>
            <a:endParaRPr lang="en-US" sz="12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232" y="69598"/>
            <a:ext cx="3935313" cy="1440871"/>
          </a:xfrm>
        </p:spPr>
      </p:pic>
      <p:sp>
        <p:nvSpPr>
          <p:cNvPr id="7" name="Rectangle 6"/>
          <p:cNvSpPr/>
          <p:nvPr/>
        </p:nvSpPr>
        <p:spPr>
          <a:xfrm>
            <a:off x="138626" y="44037"/>
            <a:ext cx="8920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CMV-Xch-1</a:t>
            </a:r>
            <a:endParaRPr lang="en-US" sz="1200" dirty="0"/>
          </a:p>
        </p:txBody>
      </p:sp>
      <p:pic>
        <p:nvPicPr>
          <p:cNvPr id="12" name="Content Placeholder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82882" y="134054"/>
            <a:ext cx="2947436" cy="1553558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8234229" y="102205"/>
            <a:ext cx="8920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CMV-Bzh-2</a:t>
            </a:r>
            <a:endParaRPr lang="en-US" sz="1200" dirty="0"/>
          </a:p>
        </p:txBody>
      </p:sp>
      <p:pic>
        <p:nvPicPr>
          <p:cNvPr id="14" name="Content Placeholder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855" y="3082160"/>
            <a:ext cx="3888067" cy="1463752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138626" y="3167464"/>
            <a:ext cx="115609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TvBMV-Bzh-3</a:t>
            </a:r>
            <a:endParaRPr lang="en-US" sz="1200" dirty="0"/>
          </a:p>
        </p:txBody>
      </p:sp>
      <p:pic>
        <p:nvPicPr>
          <p:cNvPr id="16" name="Content Placeholder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4570" y="1616817"/>
            <a:ext cx="3501149" cy="1186984"/>
          </a:xfrm>
          <a:prstGeom prst="rect">
            <a:avLst/>
          </a:prstGeom>
        </p:spPr>
      </p:pic>
      <p:pic>
        <p:nvPicPr>
          <p:cNvPr id="20" name="Content Placeholder 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4570" y="2834109"/>
            <a:ext cx="3313355" cy="1756266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4132090" y="3177153"/>
            <a:ext cx="121935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TvBMV-Bzh-5</a:t>
            </a:r>
            <a:endParaRPr lang="en-US" sz="1200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144" y="1393094"/>
            <a:ext cx="3898957" cy="177437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0922" y="256635"/>
            <a:ext cx="3730193" cy="1308397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4558605" y="65046"/>
            <a:ext cx="8920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PVY-Xch-1</a:t>
            </a:r>
            <a:endParaRPr lang="en-US" sz="1200" dirty="0"/>
          </a:p>
        </p:txBody>
      </p:sp>
      <p:sp>
        <p:nvSpPr>
          <p:cNvPr id="25" name="Rectangle 24"/>
          <p:cNvSpPr/>
          <p:nvPr/>
        </p:nvSpPr>
        <p:spPr>
          <a:xfrm>
            <a:off x="48982" y="1666392"/>
            <a:ext cx="9816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PeMV-Xch-1</a:t>
            </a:r>
            <a:endParaRPr lang="en-US" sz="12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58325" y="1619888"/>
            <a:ext cx="2967704" cy="1504461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8315719" y="1532573"/>
            <a:ext cx="10515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CMV-</a:t>
            </a:r>
            <a:r>
              <a:rPr lang="en-US" sz="1200" b="1" dirty="0" err="1" smtClean="0">
                <a:solidFill>
                  <a:prstClr val="black"/>
                </a:solidFill>
              </a:rPr>
              <a:t>Xch</a:t>
            </a:r>
            <a:r>
              <a:rPr lang="en-US" sz="1200" b="1" dirty="0" smtClean="0">
                <a:solidFill>
                  <a:prstClr val="black"/>
                </a:solidFill>
              </a:rPr>
              <a:t>-</a:t>
            </a:r>
            <a:r>
              <a:rPr lang="en-US" sz="1200" b="1" dirty="0" err="1" smtClean="0">
                <a:solidFill>
                  <a:prstClr val="black"/>
                </a:solidFill>
              </a:rPr>
              <a:t>Wh</a:t>
            </a:r>
            <a:endParaRPr lang="en-US" sz="12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39692" y="3064957"/>
            <a:ext cx="3354593" cy="1541057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8166774" y="2954448"/>
            <a:ext cx="10515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PVY-</a:t>
            </a:r>
            <a:r>
              <a:rPr lang="en-US" sz="1200" b="1" dirty="0" err="1" smtClean="0">
                <a:solidFill>
                  <a:prstClr val="black"/>
                </a:solidFill>
              </a:rPr>
              <a:t>Xch</a:t>
            </a:r>
            <a:r>
              <a:rPr lang="en-US" sz="1200" b="1" dirty="0" smtClean="0">
                <a:solidFill>
                  <a:prstClr val="black"/>
                </a:solidFill>
              </a:rPr>
              <a:t>-</a:t>
            </a:r>
            <a:r>
              <a:rPr lang="en-US" sz="1200" b="1" dirty="0" err="1" smtClean="0">
                <a:solidFill>
                  <a:prstClr val="black"/>
                </a:solidFill>
              </a:rPr>
              <a:t>Wh</a:t>
            </a:r>
            <a:endParaRPr lang="en-US" sz="1200" dirty="0"/>
          </a:p>
        </p:txBody>
      </p:sp>
      <p:pic>
        <p:nvPicPr>
          <p:cNvPr id="27" name="Content Placeholder 3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940" y="4745668"/>
            <a:ext cx="3885605" cy="1400568"/>
          </a:xfrm>
          <a:prstGeom prst="rect">
            <a:avLst/>
          </a:prstGeom>
        </p:spPr>
      </p:pic>
      <p:sp>
        <p:nvSpPr>
          <p:cNvPr id="28" name="Rectangle 27"/>
          <p:cNvSpPr/>
          <p:nvPr/>
        </p:nvSpPr>
        <p:spPr>
          <a:xfrm>
            <a:off x="132324" y="4447655"/>
            <a:ext cx="10515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 smtClean="0">
                <a:solidFill>
                  <a:prstClr val="black"/>
                </a:solidFill>
              </a:rPr>
              <a:t>BrYV-Xch-Wh</a:t>
            </a:r>
            <a:endParaRPr lang="en-US" sz="1200" dirty="0"/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5447" y="4724654"/>
            <a:ext cx="3486374" cy="1508759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4574958" y="4561178"/>
            <a:ext cx="115727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 smtClean="0">
                <a:solidFill>
                  <a:prstClr val="black"/>
                </a:solidFill>
              </a:rPr>
              <a:t>CvMV-Dzh-Qyg</a:t>
            </a:r>
            <a:endParaRPr lang="en-US" sz="1200" dirty="0"/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78037" y="4762202"/>
            <a:ext cx="3357126" cy="1471211"/>
          </a:xfrm>
          <a:prstGeom prst="rect">
            <a:avLst/>
          </a:prstGeom>
        </p:spPr>
      </p:pic>
      <p:sp>
        <p:nvSpPr>
          <p:cNvPr id="32" name="Rectangle 31"/>
          <p:cNvSpPr/>
          <p:nvPr/>
        </p:nvSpPr>
        <p:spPr>
          <a:xfrm>
            <a:off x="8347656" y="4499105"/>
            <a:ext cx="115727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PVY-Bzh-1</a:t>
            </a:r>
            <a:endParaRPr lang="en-US" sz="1200" dirty="0"/>
          </a:p>
        </p:txBody>
      </p:sp>
      <p:sp>
        <p:nvSpPr>
          <p:cNvPr id="19" name="Rectangle 18"/>
          <p:cNvSpPr/>
          <p:nvPr/>
        </p:nvSpPr>
        <p:spPr>
          <a:xfrm>
            <a:off x="4264006" y="1531407"/>
            <a:ext cx="8920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PVY-Bzh-4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929800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ounded Rectangle 10"/>
          <p:cNvSpPr/>
          <p:nvPr/>
        </p:nvSpPr>
        <p:spPr>
          <a:xfrm>
            <a:off x="4298089" y="3915784"/>
            <a:ext cx="3921573" cy="731521"/>
          </a:xfrm>
          <a:prstGeom prst="round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ounded Rectangle 9"/>
          <p:cNvSpPr/>
          <p:nvPr/>
        </p:nvSpPr>
        <p:spPr>
          <a:xfrm>
            <a:off x="4768139" y="3014832"/>
            <a:ext cx="2880548" cy="554020"/>
          </a:xfrm>
          <a:prstGeom prst="round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ounded Rectangle 8"/>
          <p:cNvSpPr/>
          <p:nvPr/>
        </p:nvSpPr>
        <p:spPr>
          <a:xfrm>
            <a:off x="4649804" y="2215842"/>
            <a:ext cx="2611607" cy="505610"/>
          </a:xfrm>
          <a:prstGeom prst="round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ounded Rectangle 5"/>
          <p:cNvSpPr/>
          <p:nvPr/>
        </p:nvSpPr>
        <p:spPr>
          <a:xfrm>
            <a:off x="3550023" y="255029"/>
            <a:ext cx="3754419" cy="1667434"/>
          </a:xfrm>
          <a:prstGeom prst="roundRect">
            <a:avLst/>
          </a:prstGeom>
          <a:solidFill>
            <a:srgbClr val="FCB0E3"/>
          </a:solidFill>
          <a:ln>
            <a:solidFill>
              <a:srgbClr val="FCB0E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ontent Placeholder 2"/>
          <p:cNvSpPr txBox="1">
            <a:spLocks noGrp="1"/>
          </p:cNvSpPr>
          <p:nvPr>
            <p:ph idx="1"/>
          </p:nvPr>
        </p:nvSpPr>
        <p:spPr>
          <a:xfrm>
            <a:off x="526340" y="6142618"/>
            <a:ext cx="10801462" cy="62394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/>
              <a:t>Fig S4. </a:t>
            </a:r>
            <a:r>
              <a:rPr lang="en-US" sz="1200" dirty="0" smtClean="0"/>
              <a:t>Phylogenetic analyses of isolates of the genus </a:t>
            </a:r>
            <a:r>
              <a:rPr lang="en-US" sz="1200" dirty="0" err="1" smtClean="0"/>
              <a:t>Potyvirus</a:t>
            </a:r>
            <a:r>
              <a:rPr lang="en-US" sz="1200" dirty="0" smtClean="0"/>
              <a:t> and some selected group members  based on complete genome sequences, generated using the neighbor-joining method and MEGA6 software. The percentage of replicate trees in which the associated taxa clustered together in the bootstrap test (1000 replicates) is shown next to the branches.</a:t>
            </a:r>
            <a:endParaRPr lang="en-US" sz="1200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8009" y="128159"/>
            <a:ext cx="7063591" cy="60144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38542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ounded Rectangle 4"/>
          <p:cNvSpPr/>
          <p:nvPr/>
        </p:nvSpPr>
        <p:spPr>
          <a:xfrm>
            <a:off x="4948517" y="107577"/>
            <a:ext cx="2345167" cy="2377440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3350" y="107577"/>
            <a:ext cx="6572922" cy="6148066"/>
          </a:xfrm>
          <a:prstGeom prst="rect">
            <a:avLst/>
          </a:prstGeom>
        </p:spPr>
      </p:pic>
      <p:sp>
        <p:nvSpPr>
          <p:cNvPr id="7" name="Content Placeholder 2"/>
          <p:cNvSpPr txBox="1">
            <a:spLocks/>
          </p:cNvSpPr>
          <p:nvPr/>
        </p:nvSpPr>
        <p:spPr>
          <a:xfrm>
            <a:off x="203498" y="6148066"/>
            <a:ext cx="11640671" cy="4678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/>
              <a:t>Fig S5. </a:t>
            </a:r>
            <a:r>
              <a:rPr lang="en-US" sz="1200" dirty="0" smtClean="0"/>
              <a:t>Phylogenetic analyses of CMV Isolates and selected </a:t>
            </a:r>
            <a:r>
              <a:rPr lang="en-US" sz="1200" dirty="0" err="1" smtClean="0"/>
              <a:t>cucumoviruses</a:t>
            </a:r>
            <a:r>
              <a:rPr lang="en-US" sz="1200" dirty="0" smtClean="0"/>
              <a:t> based on complete genome sequences, generated using the neighbor-joining method and MEGA6 software. The percentage of replicate trees in which the associated taxa clustered together in the bootstrap test (1000 replicates) is shown next to the branche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7539396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ounded Rectangle 8"/>
          <p:cNvSpPr/>
          <p:nvPr/>
        </p:nvSpPr>
        <p:spPr>
          <a:xfrm>
            <a:off x="7702475" y="129092"/>
            <a:ext cx="2151530" cy="1097280"/>
          </a:xfrm>
          <a:prstGeom prst="round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ounded Rectangle 7"/>
          <p:cNvSpPr/>
          <p:nvPr/>
        </p:nvSpPr>
        <p:spPr>
          <a:xfrm>
            <a:off x="2323652" y="505610"/>
            <a:ext cx="1172584" cy="505610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7267" y="505610"/>
            <a:ext cx="2570181" cy="176529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32699" y="0"/>
            <a:ext cx="5938221" cy="4103950"/>
          </a:xfrm>
          <a:prstGeom prst="rect">
            <a:avLst/>
          </a:prstGeom>
        </p:spPr>
      </p:pic>
      <p:sp>
        <p:nvSpPr>
          <p:cNvPr id="10" name="Content Placeholder 2"/>
          <p:cNvSpPr txBox="1">
            <a:spLocks noGrp="1"/>
          </p:cNvSpPr>
          <p:nvPr>
            <p:ph idx="1"/>
          </p:nvPr>
        </p:nvSpPr>
        <p:spPr>
          <a:xfrm>
            <a:off x="730250" y="5324475"/>
            <a:ext cx="10515600" cy="65677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/>
              <a:t>Fig S6. </a:t>
            </a:r>
            <a:r>
              <a:rPr lang="en-US" sz="1200" dirty="0" smtClean="0"/>
              <a:t>Phylogenetic analyses of isolates of the genus </a:t>
            </a:r>
            <a:r>
              <a:rPr lang="en-US" sz="1200" dirty="0" err="1" smtClean="0"/>
              <a:t>Poleroviruss</a:t>
            </a:r>
            <a:r>
              <a:rPr lang="en-US" sz="1200" dirty="0" smtClean="0"/>
              <a:t> (A) and </a:t>
            </a:r>
            <a:r>
              <a:rPr lang="en-US" sz="1200" dirty="0" err="1" smtClean="0"/>
              <a:t>Tobamovirus</a:t>
            </a:r>
            <a:r>
              <a:rPr lang="en-US" sz="1200" dirty="0" smtClean="0"/>
              <a:t> (B) based on complete genome sequences, generated using the neighbor-joining method and MEGA6 software. The percentage of replicate trees in which the associated taxa clustered together in the bootstrap test (1000 replicates) is shown next to the branche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1765804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/>
          <p:nvPr/>
        </p:nvPicPr>
        <p:blipFill>
          <a:blip r:embed="rId2"/>
          <a:stretch>
            <a:fillRect/>
          </a:stretch>
        </p:blipFill>
        <p:spPr>
          <a:xfrm>
            <a:off x="956533" y="311972"/>
            <a:ext cx="7703373" cy="2951309"/>
          </a:xfrm>
          <a:prstGeom prst="rect">
            <a:avLst/>
          </a:prstGeom>
        </p:spPr>
      </p:pic>
      <p:pic>
        <p:nvPicPr>
          <p:cNvPr id="5" name="Picture 4"/>
          <p:cNvPicPr/>
          <p:nvPr/>
        </p:nvPicPr>
        <p:blipFill>
          <a:blip r:embed="rId3"/>
          <a:stretch>
            <a:fillRect/>
          </a:stretch>
        </p:blipFill>
        <p:spPr>
          <a:xfrm>
            <a:off x="956533" y="3431690"/>
            <a:ext cx="7703373" cy="2592593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681317" y="6192692"/>
            <a:ext cx="1048512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宋体" panose="02010600030101010101" pitchFamily="2" charset="-122"/>
                <a:cs typeface="URWPalladioL-Roma"/>
              </a:rPr>
              <a:t>Fig S7a and S7b. </a:t>
            </a:r>
            <a:r>
              <a:rPr lang="en-US" sz="12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utative recombination event involving </a:t>
            </a:r>
            <a:r>
              <a:rPr lang="en-US" sz="1200" dirty="0" smtClean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(a) Potato virus Y and (b) Cucumber mosaic virus isolates </a:t>
            </a:r>
            <a:r>
              <a:rPr lang="en-US" sz="12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rom Tobacco calculated by Recombination Detection Program v. 4.16. </a:t>
            </a:r>
            <a:endParaRPr lang="en-US" sz="1200" dirty="0"/>
          </a:p>
        </p:txBody>
      </p:sp>
      <p:sp>
        <p:nvSpPr>
          <p:cNvPr id="7" name="Rectangle 6"/>
          <p:cNvSpPr/>
          <p:nvPr/>
        </p:nvSpPr>
        <p:spPr>
          <a:xfrm>
            <a:off x="532077" y="127306"/>
            <a:ext cx="2984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宋体" panose="02010600030101010101" pitchFamily="2" charset="-122"/>
                <a:cs typeface="URWPalladioL-Roma"/>
              </a:rPr>
              <a:t>a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523347" y="3284797"/>
            <a:ext cx="3080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anose="020F0502020204030204" pitchFamily="34" charset="0"/>
                <a:ea typeface="宋体" panose="02010600030101010101" pitchFamily="2" charset="-122"/>
              </a:rPr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8931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76</TotalTime>
  <Words>308</Words>
  <Application>Microsoft Office PowerPoint</Application>
  <PresentationFormat>Widescreen</PresentationFormat>
  <Paragraphs>3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Times New Roman</vt:lpstr>
      <vt:lpstr>URWPalladioL-Roma</vt:lpstr>
      <vt:lpstr>Office Theme</vt:lpstr>
      <vt:lpstr>Supplementary Figures</vt:lpstr>
      <vt:lpstr>PowerPoint Presentation</vt:lpstr>
      <vt:lpstr>Supplementary  Fig S3: Distribution of siRNA Reads on Reference Genome shows coverage across the reference</vt:lpstr>
      <vt:lpstr>PowerPoint Presentation</vt:lpstr>
      <vt:lpstr>PowerPoint Presentation</vt:lpstr>
      <vt:lpstr>PowerPoint Presentation</vt:lpstr>
      <vt:lpstr>PowerPoint Presentation</vt:lpstr>
    </vt:vector>
  </TitlesOfParts>
  <Company>chin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oBVT</dc:creator>
  <cp:lastModifiedBy>AutoBVT</cp:lastModifiedBy>
  <cp:revision>24</cp:revision>
  <dcterms:created xsi:type="dcterms:W3CDTF">2016-07-25T03:15:46Z</dcterms:created>
  <dcterms:modified xsi:type="dcterms:W3CDTF">2016-09-15T15:26:53Z</dcterms:modified>
</cp:coreProperties>
</file>